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89" r:id="rId2"/>
    <p:sldId id="290" r:id="rId3"/>
    <p:sldId id="291" r:id="rId4"/>
    <p:sldId id="292" r:id="rId5"/>
    <p:sldId id="296" r:id="rId6"/>
    <p:sldId id="299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4" autoAdjust="0"/>
    <p:restoredTop sz="93741" autoAdjust="0"/>
  </p:normalViewPr>
  <p:slideViewPr>
    <p:cSldViewPr snapToGrid="0">
      <p:cViewPr>
        <p:scale>
          <a:sx n="89" d="100"/>
          <a:sy n="89" d="100"/>
        </p:scale>
        <p:origin x="1024" y="-10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E07771-E0A4-4C9C-B6E2-D2AA160B267D}" type="datetimeFigureOut">
              <a:rPr lang="en-US" smtClean="0"/>
              <a:t>4/5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5C7BBE-ECE8-424E-AD85-045021E19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0031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41585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64401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09146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841693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737857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668354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04233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39241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205195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96559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84471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314C3-F5AC-402F-9417-870D6BC3DD35}" type="datetimeFigureOut">
              <a:rPr lang="th-TH" smtClean="0"/>
              <a:t>05/04/69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6AFFD-D119-424B-9E2F-0FCD4E758009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07189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13.png"/><Relationship Id="rId26" Type="http://schemas.openxmlformats.org/officeDocument/2006/relationships/image" Target="../media/image17.png"/><Relationship Id="rId21" Type="http://schemas.microsoft.com/office/2007/relationships/hdphoto" Target="../media/hdphoto10.wdp"/><Relationship Id="rId34" Type="http://schemas.openxmlformats.org/officeDocument/2006/relationships/image" Target="../media/image21.png"/><Relationship Id="rId7" Type="http://schemas.microsoft.com/office/2007/relationships/hdphoto" Target="../media/hdphoto3.wdp"/><Relationship Id="rId12" Type="http://schemas.openxmlformats.org/officeDocument/2006/relationships/image" Target="../media/image10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2" Type="http://schemas.openxmlformats.org/officeDocument/2006/relationships/image" Target="../media/image5.png"/><Relationship Id="rId16" Type="http://schemas.openxmlformats.org/officeDocument/2006/relationships/image" Target="../media/image12.png"/><Relationship Id="rId20" Type="http://schemas.openxmlformats.org/officeDocument/2006/relationships/image" Target="../media/image14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microsoft.com/office/2007/relationships/hdphoto" Target="../media/hdphoto5.wdp"/><Relationship Id="rId24" Type="http://schemas.openxmlformats.org/officeDocument/2006/relationships/image" Target="../media/image16.png"/><Relationship Id="rId32" Type="http://schemas.openxmlformats.org/officeDocument/2006/relationships/image" Target="../media/image20.png"/><Relationship Id="rId37" Type="http://schemas.microsoft.com/office/2007/relationships/hdphoto" Target="../media/hdphoto18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8.png"/><Relationship Id="rId36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6.png"/><Relationship Id="rId9" Type="http://schemas.microsoft.com/office/2007/relationships/hdphoto" Target="../media/hdphoto4.wdp"/><Relationship Id="rId14" Type="http://schemas.openxmlformats.org/officeDocument/2006/relationships/image" Target="../media/image11.png"/><Relationship Id="rId22" Type="http://schemas.openxmlformats.org/officeDocument/2006/relationships/image" Target="../media/image15.png"/><Relationship Id="rId27" Type="http://schemas.microsoft.com/office/2007/relationships/hdphoto" Target="../media/hdphoto13.wdp"/><Relationship Id="rId30" Type="http://schemas.openxmlformats.org/officeDocument/2006/relationships/image" Target="../media/image19.png"/><Relationship Id="rId35" Type="http://schemas.microsoft.com/office/2007/relationships/hdphoto" Target="../media/hdphoto17.wdp"/><Relationship Id="rId8" Type="http://schemas.openxmlformats.org/officeDocument/2006/relationships/image" Target="../media/image8.png"/><Relationship Id="rId3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 descr="รูปภาพประกอบด้วย ข้อความ, ภาพหน้าจอ, แผนภาพ, ออกแบบ&#10;&#10;เนื้อหาที่สร้างโดย AI อาจไม่ถูกต้อง">
            <a:extLst>
              <a:ext uri="{FF2B5EF4-FFF2-40B4-BE49-F238E27FC236}">
                <a16:creationId xmlns:a16="http://schemas.microsoft.com/office/drawing/2014/main" id="{B5A76E53-821F-E4F1-D685-DBD8F5C900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657" y="1241334"/>
            <a:ext cx="5486400" cy="48107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A67EF06-93CA-BF2A-B823-C9F69258BF40}"/>
              </a:ext>
            </a:extLst>
          </p:cNvPr>
          <p:cNvSpPr txBox="1"/>
          <p:nvPr/>
        </p:nvSpPr>
        <p:spPr>
          <a:xfrm>
            <a:off x="608908" y="6318704"/>
            <a:ext cx="5486400" cy="8002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OE-L⁺NLCs preparation process.</a:t>
            </a:r>
            <a:b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pwise illustration of the emulsification–sonication technique used to produce oregano oil–lauric acid cationic nanostructured lipid carriers.</a:t>
            </a:r>
          </a:p>
          <a:p>
            <a:pPr marL="0" marR="0" algn="just">
              <a:buNone/>
            </a:pPr>
            <a:endParaRPr lang="en-US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5522952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 descr="รูปภาพประกอบด้วย ข้อความ, ภาพหน้าจอ, แผนภาพ, วงกลม&#10;&#10;เนื้อหาที่สร้างโดย AI อาจไม่ถูกต้อง">
            <a:extLst>
              <a:ext uri="{FF2B5EF4-FFF2-40B4-BE49-F238E27FC236}">
                <a16:creationId xmlns:a16="http://schemas.microsoft.com/office/drawing/2014/main" id="{E6030C4E-7399-C6F6-8DD4-10083FE11C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332" y="772247"/>
            <a:ext cx="4806950" cy="463740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0F86DF-7513-DC03-B9EB-1FCB30525EC5}"/>
              </a:ext>
            </a:extLst>
          </p:cNvPr>
          <p:cNvSpPr txBox="1"/>
          <p:nvPr/>
        </p:nvSpPr>
        <p:spPr>
          <a:xfrm>
            <a:off x="540327" y="5617894"/>
            <a:ext cx="581059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microplate images of MIC and MBC assays. Visual confirmation of bacterial inhibition zones corresponding to the microdilution assay results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galacti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15541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 descr="รูปภาพประกอบด้วย ข้อความ, ภาพหน้าจอ&#10;&#10;เนื้อหาที่สร้างโดย AI อาจไม่ถูกต้อง">
            <a:extLst>
              <a:ext uri="{FF2B5EF4-FFF2-40B4-BE49-F238E27FC236}">
                <a16:creationId xmlns:a16="http://schemas.microsoft.com/office/drawing/2014/main" id="{B9EE5B81-57F7-925E-7189-77DAD520ED8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5312" y="2704205"/>
            <a:ext cx="4182110" cy="231965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4439100-29AC-5161-B6C5-26492589668B}"/>
              </a:ext>
            </a:extLst>
          </p:cNvPr>
          <p:cNvSpPr txBox="1"/>
          <p:nvPr/>
        </p:nvSpPr>
        <p:spPr>
          <a:xfrm>
            <a:off x="1190797" y="5368513"/>
            <a:ext cx="4495107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diagram of the in vitro digestion procedure. Experimental setup showing simulated gastric (SGF) and intestinal (SIF) digestion steps for evaluating formulation stability and bioactivity.</a:t>
            </a:r>
          </a:p>
        </p:txBody>
      </p:sp>
    </p:spTree>
    <p:extLst>
      <p:ext uri="{BB962C8B-B14F-4D97-AF65-F5344CB8AC3E}">
        <p14:creationId xmlns:p14="http://schemas.microsoft.com/office/powerpoint/2010/main" val="27847401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 descr="รูปภาพประกอบด้วย ขวด, วิธีการแก้, ของเหลว, ขวดพลาสติก&#10;&#10;เนื้อหาที่สร้างโดย AI อาจไม่ถูกต้อง">
            <a:extLst>
              <a:ext uri="{FF2B5EF4-FFF2-40B4-BE49-F238E27FC236}">
                <a16:creationId xmlns:a16="http://schemas.microsoft.com/office/drawing/2014/main" id="{18302D95-ADF5-B753-FF0F-B7DFDCE1F68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7557" y="2437735"/>
            <a:ext cx="4189200" cy="21010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52E86C7-4529-6131-C118-B24730E6EEAC}"/>
              </a:ext>
            </a:extLst>
          </p:cNvPr>
          <p:cNvSpPr txBox="1"/>
          <p:nvPr/>
        </p:nvSpPr>
        <p:spPr>
          <a:xfrm>
            <a:off x="1237557" y="4806339"/>
            <a:ext cx="41892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appearance of oregano oil–lauric acid cationic nanostructured lipid carriers (OE-L⁺NLCs) and control formulations 24 h after preparation at 25 °C. (A) OE-L⁺NLCs, (B) OE-NLCs, (C) L⁺NLCs, (D) blank NLCs, (E) oregano oil (OE) solution, and (F) lauric acid (L⁺) solution. Formulations containing NLCs exhibited uniform emulsion appearance without phase separation.</a:t>
            </a:r>
          </a:p>
        </p:txBody>
      </p:sp>
    </p:spTree>
    <p:extLst>
      <p:ext uri="{BB962C8B-B14F-4D97-AF65-F5344CB8AC3E}">
        <p14:creationId xmlns:p14="http://schemas.microsoft.com/office/powerpoint/2010/main" val="32294688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>
            <a:extLst>
              <a:ext uri="{FF2B5EF4-FFF2-40B4-BE49-F238E27FC236}">
                <a16:creationId xmlns:a16="http://schemas.microsoft.com/office/drawing/2014/main" id="{04102205-F547-4C7C-9DC1-EF6EEFD543B7}"/>
              </a:ext>
            </a:extLst>
          </p:cNvPr>
          <p:cNvGrpSpPr/>
          <p:nvPr/>
        </p:nvGrpSpPr>
        <p:grpSpPr>
          <a:xfrm>
            <a:off x="174464" y="1279251"/>
            <a:ext cx="6509072" cy="4760017"/>
            <a:chOff x="87546" y="1027791"/>
            <a:chExt cx="6509072" cy="4760017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4E74FF6F-4D5E-CC22-7109-24043630C189}"/>
                </a:ext>
              </a:extLst>
            </p:cNvPr>
            <p:cNvGrpSpPr/>
            <p:nvPr/>
          </p:nvGrpSpPr>
          <p:grpSpPr>
            <a:xfrm>
              <a:off x="87546" y="1027791"/>
              <a:ext cx="6509072" cy="1760768"/>
              <a:chOff x="87546" y="1027791"/>
              <a:chExt cx="6509072" cy="1760768"/>
            </a:xfrm>
          </p:grpSpPr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FB00213C-A5EC-F1C0-4648-08F232D5E4DA}"/>
                  </a:ext>
                </a:extLst>
              </p:cNvPr>
              <p:cNvGrpSpPr/>
              <p:nvPr/>
            </p:nvGrpSpPr>
            <p:grpSpPr>
              <a:xfrm>
                <a:off x="672566" y="1027791"/>
                <a:ext cx="5924052" cy="1760768"/>
                <a:chOff x="640962" y="2084157"/>
                <a:chExt cx="5924052" cy="1760768"/>
              </a:xfrm>
            </p:grpSpPr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DB743C9B-9548-2D4D-69F5-678A7B06D09E}"/>
                    </a:ext>
                  </a:extLst>
                </p:cNvPr>
                <p:cNvGrpSpPr/>
                <p:nvPr/>
              </p:nvGrpSpPr>
              <p:grpSpPr>
                <a:xfrm>
                  <a:off x="867413" y="2461260"/>
                  <a:ext cx="5472190" cy="1383665"/>
                  <a:chOff x="867413" y="2461260"/>
                  <a:chExt cx="5472190" cy="1383665"/>
                </a:xfrm>
              </p:grpSpPr>
              <p:pic>
                <p:nvPicPr>
                  <p:cNvPr id="9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    <a:extLst>
                      <a:ext uri="{FF2B5EF4-FFF2-40B4-BE49-F238E27FC236}">
                        <a16:creationId xmlns:a16="http://schemas.microsoft.com/office/drawing/2014/main" id="{9DC71EB0-BA66-52A0-6CB8-1CF8A91566B7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268" t="36908" r="80365" b="34211"/>
                  <a:stretch/>
                </p:blipFill>
                <p:spPr bwMode="auto">
                  <a:xfrm>
                    <a:off x="867413" y="2473325"/>
                    <a:ext cx="457200" cy="1371600"/>
                  </a:xfrm>
                  <a:prstGeom prst="round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10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    <a:extLst>
                      <a:ext uri="{FF2B5EF4-FFF2-40B4-BE49-F238E27FC236}">
                        <a16:creationId xmlns:a16="http://schemas.microsoft.com/office/drawing/2014/main" id="{4EBF6601-668A-0145-4D4D-7F0A15426F5F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8698" t="2020" r="65515" b="68015"/>
                  <a:stretch/>
                </p:blipFill>
                <p:spPr bwMode="auto">
                  <a:xfrm>
                    <a:off x="1869038" y="2461260"/>
                    <a:ext cx="457200" cy="1371600"/>
                  </a:xfrm>
                  <a:prstGeom prst="round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11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    <a:extLst>
                      <a:ext uri="{FF2B5EF4-FFF2-40B4-BE49-F238E27FC236}">
                        <a16:creationId xmlns:a16="http://schemas.microsoft.com/office/drawing/2014/main" id="{5CA6B03B-7AAB-1F6C-28DF-E4C36B06985D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4735" t="35626" r="50419" b="34434"/>
                  <a:stretch/>
                </p:blipFill>
                <p:spPr bwMode="auto">
                  <a:xfrm>
                    <a:off x="2870664" y="2471616"/>
                    <a:ext cx="457200" cy="1371600"/>
                  </a:xfrm>
                  <a:prstGeom prst="round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12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    <a:extLst>
                      <a:ext uri="{FF2B5EF4-FFF2-40B4-BE49-F238E27FC236}">
                        <a16:creationId xmlns:a16="http://schemas.microsoft.com/office/drawing/2014/main" id="{ED165849-E948-1DB8-C2E9-083AA6968A58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8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9568" t="34899" r="34993" b="34971"/>
                  <a:stretch/>
                </p:blipFill>
                <p:spPr bwMode="auto">
                  <a:xfrm>
                    <a:off x="3875721" y="2471616"/>
                    <a:ext cx="457200" cy="1371600"/>
                  </a:xfrm>
                  <a:prstGeom prst="round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13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    <a:extLst>
                      <a:ext uri="{FF2B5EF4-FFF2-40B4-BE49-F238E27FC236}">
                        <a16:creationId xmlns:a16="http://schemas.microsoft.com/office/drawing/2014/main" id="{E4EFDD49-3946-5090-021E-2B19B24D0604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10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1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3822" t="35443" r="18969" b="33899"/>
                  <a:stretch/>
                </p:blipFill>
                <p:spPr bwMode="auto">
                  <a:xfrm>
                    <a:off x="4880778" y="2473192"/>
                    <a:ext cx="457200" cy="1371600"/>
                  </a:xfrm>
                  <a:prstGeom prst="round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14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    <a:extLst>
                      <a:ext uri="{FF2B5EF4-FFF2-40B4-BE49-F238E27FC236}">
                        <a16:creationId xmlns:a16="http://schemas.microsoft.com/office/drawing/2014/main" id="{D4B1AFD3-D2D0-9760-D72A-F1B283BBC63E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1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0140" t="35289" r="3519" b="33899"/>
                  <a:stretch/>
                </p:blipFill>
                <p:spPr bwMode="auto">
                  <a:xfrm>
                    <a:off x="5882403" y="2471616"/>
                    <a:ext cx="457200" cy="1371600"/>
                  </a:xfrm>
                  <a:prstGeom prst="round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</p:grpSp>
            <p:grpSp>
              <p:nvGrpSpPr>
                <p:cNvPr id="30" name="Group 29">
                  <a:extLst>
                    <a:ext uri="{FF2B5EF4-FFF2-40B4-BE49-F238E27FC236}">
                      <a16:creationId xmlns:a16="http://schemas.microsoft.com/office/drawing/2014/main" id="{69165A41-2AEC-1CC8-DB15-FECD19EC1357}"/>
                    </a:ext>
                  </a:extLst>
                </p:cNvPr>
                <p:cNvGrpSpPr/>
                <p:nvPr/>
              </p:nvGrpSpPr>
              <p:grpSpPr>
                <a:xfrm>
                  <a:off x="640962" y="2084157"/>
                  <a:ext cx="5924052" cy="267641"/>
                  <a:chOff x="640962" y="2084157"/>
                  <a:chExt cx="5924052" cy="267641"/>
                </a:xfrm>
              </p:grpSpPr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36401FDB-BFE6-C5AB-B51E-40452C891053}"/>
                      </a:ext>
                    </a:extLst>
                  </p:cNvPr>
                  <p:cNvSpPr txBox="1"/>
                  <p:nvPr/>
                </p:nvSpPr>
                <p:spPr>
                  <a:xfrm>
                    <a:off x="640962" y="2084157"/>
                    <a:ext cx="914722" cy="261610"/>
                  </a:xfrm>
                  <a:prstGeom prst="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OE-L</a:t>
                    </a:r>
                    <a:r>
                      <a:rPr lang="en-US" sz="1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+</a:t>
                    </a:r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NLCs</a:t>
                    </a:r>
                    <a:endParaRPr lang="en-US" sz="1100" dirty="0"/>
                  </a:p>
                </p:txBody>
              </p:sp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3892996E-F4AA-79C1-5823-B4E249DB02E2}"/>
                      </a:ext>
                    </a:extLst>
                  </p:cNvPr>
                  <p:cNvSpPr txBox="1"/>
                  <p:nvPr/>
                </p:nvSpPr>
                <p:spPr>
                  <a:xfrm>
                    <a:off x="1643951" y="2084157"/>
                    <a:ext cx="914400" cy="261610"/>
                  </a:xfrm>
                  <a:prstGeom prst="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OE-NLCs</a:t>
                    </a:r>
                    <a:endParaRPr lang="en-US" sz="1100" dirty="0"/>
                  </a:p>
                </p:txBody>
              </p:sp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37F889A5-38A8-171B-C040-0F27ACF68E58}"/>
                      </a:ext>
                    </a:extLst>
                  </p:cNvPr>
                  <p:cNvSpPr txBox="1"/>
                  <p:nvPr/>
                </p:nvSpPr>
                <p:spPr>
                  <a:xfrm>
                    <a:off x="3647121" y="2084157"/>
                    <a:ext cx="914400" cy="261610"/>
                  </a:xfrm>
                  <a:prstGeom prst="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NLCs</a:t>
                    </a:r>
                    <a:endParaRPr lang="en-US" sz="1100" dirty="0"/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4EB576AD-0004-F060-B2FB-B76809770713}"/>
                      </a:ext>
                    </a:extLst>
                  </p:cNvPr>
                  <p:cNvSpPr txBox="1"/>
                  <p:nvPr/>
                </p:nvSpPr>
                <p:spPr>
                  <a:xfrm>
                    <a:off x="2645536" y="2090188"/>
                    <a:ext cx="914400" cy="261610"/>
                  </a:xfrm>
                  <a:prstGeom prst="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L</a:t>
                    </a:r>
                    <a:r>
                      <a:rPr lang="en-US" sz="1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+</a:t>
                    </a:r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NLCs</a:t>
                    </a:r>
                    <a:endParaRPr lang="en-US" sz="1100" dirty="0"/>
                  </a:p>
                </p:txBody>
              </p: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C04901FB-C3C4-43D1-245B-8E6FCF2AFD0A}"/>
                      </a:ext>
                    </a:extLst>
                  </p:cNvPr>
                  <p:cNvSpPr txBox="1"/>
                  <p:nvPr/>
                </p:nvSpPr>
                <p:spPr>
                  <a:xfrm>
                    <a:off x="4649788" y="2084157"/>
                    <a:ext cx="914400" cy="261610"/>
                  </a:xfrm>
                  <a:prstGeom prst="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OE Solution</a:t>
                    </a:r>
                    <a:endParaRPr lang="en-US" sz="1100" dirty="0"/>
                  </a:p>
                </p:txBody>
              </p:sp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59AE261C-4FE7-BF14-3298-59E54FC125E0}"/>
                      </a:ext>
                    </a:extLst>
                  </p:cNvPr>
                  <p:cNvSpPr txBox="1"/>
                  <p:nvPr/>
                </p:nvSpPr>
                <p:spPr>
                  <a:xfrm>
                    <a:off x="5650292" y="2088376"/>
                    <a:ext cx="914722" cy="261610"/>
                  </a:xfrm>
                  <a:prstGeom prst="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L</a:t>
                    </a:r>
                    <a:r>
                      <a:rPr lang="en-US" sz="1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+</a:t>
                    </a:r>
                    <a:r>
                      <a:rPr lang="en-US" sz="1100" baseline="30000" dirty="0"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 </a:t>
                    </a:r>
                    <a:r>
                      <a:rPr lang="en-US" sz="1100" dirty="0"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S</a:t>
                    </a:r>
                    <a:r>
                      <a: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rPr>
                      <a:t>olution </a:t>
                    </a:r>
                    <a:endParaRPr lang="en-US" sz="1100" dirty="0"/>
                  </a:p>
                </p:txBody>
              </p:sp>
            </p:grpSp>
          </p:grp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23438757-B487-C2FA-D61D-C03F03A183C2}"/>
                  </a:ext>
                </a:extLst>
              </p:cNvPr>
              <p:cNvSpPr txBox="1"/>
              <p:nvPr/>
            </p:nvSpPr>
            <p:spPr>
              <a:xfrm>
                <a:off x="87546" y="1970245"/>
                <a:ext cx="527226" cy="261610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</a:rPr>
                  <a:t>4°C</a:t>
                </a:r>
                <a:endParaRPr lang="en-US" sz="1100" dirty="0"/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923B08B5-ADD2-6EEC-01A9-A5819B89777E}"/>
                </a:ext>
              </a:extLst>
            </p:cNvPr>
            <p:cNvGrpSpPr/>
            <p:nvPr/>
          </p:nvGrpSpPr>
          <p:grpSpPr>
            <a:xfrm>
              <a:off x="87546" y="2916116"/>
              <a:ext cx="6276692" cy="1401257"/>
              <a:chOff x="87546" y="2916116"/>
              <a:chExt cx="6276692" cy="1401257"/>
            </a:xfrm>
          </p:grpSpPr>
          <p:pic>
            <p:nvPicPr>
              <p:cNvPr id="2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<a:extLst>
                  <a:ext uri="{FF2B5EF4-FFF2-40B4-BE49-F238E27FC236}">
                    <a16:creationId xmlns:a16="http://schemas.microsoft.com/office/drawing/2014/main" id="{1955CC4D-BCAD-C54A-1B09-CA20895B9115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65" t="2379" r="81301" b="69152"/>
              <a:stretch/>
            </p:blipFill>
            <p:spPr bwMode="auto">
              <a:xfrm>
                <a:off x="899017" y="2916116"/>
                <a:ext cx="457200" cy="1371600"/>
              </a:xfrm>
              <a:prstGeom prst="round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" name="รูปภาพ 3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<a:extLst>
                  <a:ext uri="{FF2B5EF4-FFF2-40B4-BE49-F238E27FC236}">
                    <a16:creationId xmlns:a16="http://schemas.microsoft.com/office/drawing/2014/main" id="{6908E9EC-3372-895F-1963-06C3701D9B5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007" t="1101" r="65866" b="68476"/>
              <a:stretch/>
            </p:blipFill>
            <p:spPr bwMode="auto">
              <a:xfrm>
                <a:off x="1907611" y="2945773"/>
                <a:ext cx="457200" cy="1371600"/>
              </a:xfrm>
              <a:prstGeom prst="round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4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<a:extLst>
                  <a:ext uri="{FF2B5EF4-FFF2-40B4-BE49-F238E27FC236}">
                    <a16:creationId xmlns:a16="http://schemas.microsoft.com/office/drawing/2014/main" id="{D07D37A6-C85A-1B70-EDC9-8D1E31538E8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026" t="69231" r="49838" b="1583"/>
              <a:stretch/>
            </p:blipFill>
            <p:spPr bwMode="auto">
              <a:xfrm>
                <a:off x="2902268" y="2916116"/>
                <a:ext cx="457200" cy="1371600"/>
              </a:xfrm>
              <a:prstGeom prst="round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5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<a:extLst>
                  <a:ext uri="{FF2B5EF4-FFF2-40B4-BE49-F238E27FC236}">
                    <a16:creationId xmlns:a16="http://schemas.microsoft.com/office/drawing/2014/main" id="{5F7770F2-29F9-1CA0-1D44-A2615AE40890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568" t="35070" r="34696" b="33897"/>
              <a:stretch/>
            </p:blipFill>
            <p:spPr bwMode="auto">
              <a:xfrm>
                <a:off x="3908937" y="2920226"/>
                <a:ext cx="453975" cy="1371600"/>
              </a:xfrm>
              <a:prstGeom prst="round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6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<a:extLst>
                  <a:ext uri="{FF2B5EF4-FFF2-40B4-BE49-F238E27FC236}">
                    <a16:creationId xmlns:a16="http://schemas.microsoft.com/office/drawing/2014/main" id="{6B01151F-7BF3-EA19-91E9-E278C3E4BF4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027" t="2021" r="19266" b="67317"/>
              <a:stretch/>
            </p:blipFill>
            <p:spPr bwMode="auto">
              <a:xfrm>
                <a:off x="4912381" y="2916116"/>
                <a:ext cx="460155" cy="1371600"/>
              </a:xfrm>
              <a:prstGeom prst="round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7" name="รูปภาพ 1" descr="รูปภาพประกอบด้วย ภาชนะเก็บอาหาร, ไหก่ออิฐ, ฝา, อาหารที่เก็บรักษาไว้&#10;&#10;เนื้อหาที่สร้างโดย AI อาจไม่ถูกต้อง">
                <a:extLst>
                  <a:ext uri="{FF2B5EF4-FFF2-40B4-BE49-F238E27FC236}">
                    <a16:creationId xmlns:a16="http://schemas.microsoft.com/office/drawing/2014/main" id="{095065B3-AB63-9487-7C02-7CE6A8932D3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4" cstate="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341" t="1837" r="2348" b="66766"/>
              <a:stretch/>
            </p:blipFill>
            <p:spPr bwMode="auto">
              <a:xfrm>
                <a:off x="5907038" y="2916116"/>
                <a:ext cx="457200" cy="1371600"/>
              </a:xfrm>
              <a:prstGeom prst="round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9FE31B66-0263-E750-5DB6-102CEB220089}"/>
                  </a:ext>
                </a:extLst>
              </p:cNvPr>
              <p:cNvSpPr txBox="1"/>
              <p:nvPr/>
            </p:nvSpPr>
            <p:spPr>
              <a:xfrm>
                <a:off x="87546" y="3471111"/>
                <a:ext cx="527226" cy="261610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</a:rPr>
                  <a:t>25°C</a:t>
                </a:r>
                <a:endParaRPr lang="en-US" sz="1100" dirty="0"/>
              </a:p>
            </p:txBody>
          </p: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350D44A2-A746-386A-6291-71E56E48EF58}"/>
                </a:ext>
              </a:extLst>
            </p:cNvPr>
            <p:cNvGrpSpPr/>
            <p:nvPr/>
          </p:nvGrpSpPr>
          <p:grpSpPr>
            <a:xfrm>
              <a:off x="87546" y="4416208"/>
              <a:ext cx="6302618" cy="1371600"/>
              <a:chOff x="87546" y="4416208"/>
              <a:chExt cx="6302618" cy="1371600"/>
            </a:xfrm>
          </p:grpSpPr>
          <p:pic>
            <p:nvPicPr>
              <p:cNvPr id="16" name="รูปภาพ 12">
                <a:extLst>
                  <a:ext uri="{FF2B5EF4-FFF2-40B4-BE49-F238E27FC236}">
                    <a16:creationId xmlns:a16="http://schemas.microsoft.com/office/drawing/2014/main" id="{4D2C071B-BF2A-F6CD-6B0F-F989C2BE836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sharpenSoften amoun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99017" y="4416208"/>
                <a:ext cx="457200" cy="1371600"/>
              </a:xfrm>
              <a:prstGeom prst="roundRect">
                <a:avLst/>
              </a:prstGeom>
              <a:noFill/>
            </p:spPr>
          </p:pic>
          <p:pic>
            <p:nvPicPr>
              <p:cNvPr id="17" name="รูปภาพ 13">
                <a:extLst>
                  <a:ext uri="{FF2B5EF4-FFF2-40B4-BE49-F238E27FC236}">
                    <a16:creationId xmlns:a16="http://schemas.microsoft.com/office/drawing/2014/main" id="{BAF75042-6E8E-C0F0-7F82-A0FD7CEF2BD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sharpenSoften amount="9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07611" y="4416208"/>
                <a:ext cx="457200" cy="1371600"/>
              </a:xfrm>
              <a:prstGeom prst="rect">
                <a:avLst/>
              </a:prstGeom>
              <a:noFill/>
            </p:spPr>
          </p:pic>
          <p:pic>
            <p:nvPicPr>
              <p:cNvPr id="18" name="รูปภาพ 5">
                <a:extLst>
                  <a:ext uri="{FF2B5EF4-FFF2-40B4-BE49-F238E27FC236}">
                    <a16:creationId xmlns:a16="http://schemas.microsoft.com/office/drawing/2014/main" id="{223B7ADD-68CB-90FB-D4E1-5261522DBDF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0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sharpenSoften amoun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02268" y="4416208"/>
                <a:ext cx="457200" cy="1371600"/>
              </a:xfrm>
              <a:prstGeom prst="rect">
                <a:avLst/>
              </a:prstGeom>
              <a:noFill/>
            </p:spPr>
          </p:pic>
          <p:pic>
            <p:nvPicPr>
              <p:cNvPr id="19" name="รูปภาพ 6">
                <a:extLst>
                  <a:ext uri="{FF2B5EF4-FFF2-40B4-BE49-F238E27FC236}">
                    <a16:creationId xmlns:a16="http://schemas.microsoft.com/office/drawing/2014/main" id="{5443CB7D-A57D-B19B-E24F-02552341FF1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2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sharpenSoften amoun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14657" y="4416208"/>
                <a:ext cx="456565" cy="1371600"/>
              </a:xfrm>
              <a:prstGeom prst="rect">
                <a:avLst/>
              </a:prstGeom>
              <a:noFill/>
            </p:spPr>
          </p:pic>
          <p:pic>
            <p:nvPicPr>
              <p:cNvPr id="20" name="รูปภาพ 7">
                <a:extLst>
                  <a:ext uri="{FF2B5EF4-FFF2-40B4-BE49-F238E27FC236}">
                    <a16:creationId xmlns:a16="http://schemas.microsoft.com/office/drawing/2014/main" id="{8898E21A-23CB-0835-7DCE-1E6ABC5F937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4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sharpenSoften amoun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23493" y="4416208"/>
                <a:ext cx="457200" cy="1371600"/>
              </a:xfrm>
              <a:prstGeom prst="rect">
                <a:avLst/>
              </a:prstGeom>
              <a:noFill/>
            </p:spPr>
          </p:pic>
          <p:pic>
            <p:nvPicPr>
              <p:cNvPr id="21" name="รูปภาพ 8">
                <a:extLst>
                  <a:ext uri="{FF2B5EF4-FFF2-40B4-BE49-F238E27FC236}">
                    <a16:creationId xmlns:a16="http://schemas.microsoft.com/office/drawing/2014/main" id="{BC3F994F-463A-AC57-7D87-EE2B95E48CD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6">
                <a:extLst>
                  <a:ext uri="{BEBA8EAE-BF5A-486C-A8C5-ECC9F3942E4B}">
                    <a14:imgProps xmlns:a14="http://schemas.microsoft.com/office/drawing/2010/main">
                      <a14:imgLayer r:embed="rId37">
                        <a14:imgEffect>
                          <a14:sharpenSoften amoun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32964" y="4416208"/>
                <a:ext cx="457200" cy="1371600"/>
              </a:xfrm>
              <a:prstGeom prst="rect">
                <a:avLst/>
              </a:prstGeom>
              <a:noFill/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207D7D8B-8EB4-9C76-08A3-73310F3F500C}"/>
                  </a:ext>
                </a:extLst>
              </p:cNvPr>
              <p:cNvSpPr txBox="1"/>
              <p:nvPr/>
            </p:nvSpPr>
            <p:spPr>
              <a:xfrm>
                <a:off x="87546" y="4841172"/>
                <a:ext cx="527226" cy="261610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</a:rPr>
                  <a:t>37°C</a:t>
                </a:r>
                <a:endParaRPr lang="en-US" sz="1100" dirty="0"/>
              </a:p>
            </p:txBody>
          </p:sp>
        </p:grp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BA3C8133-ED86-1A63-332B-2F5D685DEB94}"/>
              </a:ext>
            </a:extLst>
          </p:cNvPr>
          <p:cNvSpPr txBox="1"/>
          <p:nvPr/>
        </p:nvSpPr>
        <p:spPr>
          <a:xfrm>
            <a:off x="328456" y="6391633"/>
            <a:ext cx="635508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stability of oregano oil–lauric acid cationic nanostructured lipid carriers (OE-L⁺NLCs) and control formulations stored at 25 °C, 4 °C, and 37 °C for 90 days. All NLC formulations (OE-L⁺NLCs, OE-NLCs, L⁺NLCs, and blank NLCs) remained homogeneous without phase separation, whereas the L⁺ solution showed crystallization at 4 °C. OE solution displayed color darkening but no solidification, indicating oxidation of free oil.</a:t>
            </a:r>
          </a:p>
        </p:txBody>
      </p:sp>
    </p:spTree>
    <p:extLst>
      <p:ext uri="{BB962C8B-B14F-4D97-AF65-F5344CB8AC3E}">
        <p14:creationId xmlns:p14="http://schemas.microsoft.com/office/powerpoint/2010/main" val="1117845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8" descr="รูปภาพประกอบด้วย เทียน, กระบอก, ในร่ม&#10;&#10;เนื้อหาที่สร้างโดย AI อาจไม่ถูกต้อง">
            <a:extLst>
              <a:ext uri="{FF2B5EF4-FFF2-40B4-BE49-F238E27FC236}">
                <a16:creationId xmlns:a16="http://schemas.microsoft.com/office/drawing/2014/main" id="{4DD90E31-63B4-110F-8AB2-BD2952BAC61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0229" y="2030253"/>
            <a:ext cx="3068955" cy="1916430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CE6AB41-3791-04E0-2BAB-8464C4BF5C2D}"/>
              </a:ext>
            </a:extLst>
          </p:cNvPr>
          <p:cNvSpPr txBox="1"/>
          <p:nvPr/>
        </p:nvSpPr>
        <p:spPr>
          <a:xfrm>
            <a:off x="1714500" y="4075837"/>
            <a:ext cx="34290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buNone/>
            </a:pPr>
            <a:r>
              <a:rPr lang="en-US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Figure S6. </a:t>
            </a:r>
            <a:r>
              <a:rPr lang="en-US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Physical characterizations</a:t>
            </a:r>
            <a:r>
              <a:rPr lang="en-US" sz="12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</a:t>
            </a:r>
            <a:r>
              <a:rPr lang="en-US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of OE-L</a:t>
            </a:r>
            <a:r>
              <a:rPr lang="en-US" sz="12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+</a:t>
            </a:r>
            <a:r>
              <a:rPr lang="en-US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NLCs, OE-NLCs, L</a:t>
            </a:r>
            <a:r>
              <a:rPr lang="en-US" sz="12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+</a:t>
            </a:r>
            <a:r>
              <a:rPr lang="en-US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NLCs and NLCs in SGF and SIF; visual observation of samples after 2 h of digestion in SGF and SIF, respectively.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94236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5351</TotalTime>
  <Words>339</Words>
  <Application>Microsoft Office PowerPoint</Application>
  <PresentationFormat>A4 Paper (210x297 mm)</PresentationFormat>
  <Paragraphs>1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mwarang Sukkarun</dc:creator>
  <cp:lastModifiedBy>Dr. Manoj Kamble</cp:lastModifiedBy>
  <cp:revision>97</cp:revision>
  <dcterms:created xsi:type="dcterms:W3CDTF">2023-02-22T02:56:45Z</dcterms:created>
  <dcterms:modified xsi:type="dcterms:W3CDTF">2026-04-05T13:44:24Z</dcterms:modified>
</cp:coreProperties>
</file>